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128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3400" y="744120"/>
            <a:ext cx="2790720" cy="3722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06480" y="4714560"/>
            <a:ext cx="498456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128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07BFF8-B198-4DF4-AC73-0EC378E76CC4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906480" y="4714560"/>
            <a:ext cx="498456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スライド番号プレースホルダー 3"/>
          <p:cNvSpPr/>
          <p:nvPr/>
        </p:nvSpPr>
        <p:spPr>
          <a:xfrm>
            <a:off x="385128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9CF646-D0B2-4018-833D-EE716B469CB1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924DC-9075-497C-9B95-F737A5EE2E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B2A43-13E7-4BAA-AF75-586B719E50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CA15A-B2EF-4D60-9637-26213357C4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68CD2-6B71-4B56-9B17-E1C504BE1F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CD2C6-9D1A-41D9-9FFC-C9CC389DD8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5AECE0-B148-41E5-97BE-02DC5267BF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EB95A-9A35-4828-A676-B6E49330EA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151F1-1A5D-4B5A-A3F6-3DA11160E9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6364E-FF00-414C-8840-40724532BA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7439E-07FB-4521-B81F-38AEB78ACC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EBDE8-5DF5-4A1F-8C0A-62E3BB368B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4BEFC-7C35-411F-9040-52EA8D8C19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2E7E12-C75E-4D90-9FE5-85516720FFA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"/>
          <p:cNvSpPr/>
          <p:nvPr/>
        </p:nvSpPr>
        <p:spPr>
          <a:xfrm>
            <a:off x="1662840" y="263520"/>
            <a:ext cx="3531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emental infomatio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正方形/長方形 2"/>
          <p:cNvSpPr/>
          <p:nvPr/>
        </p:nvSpPr>
        <p:spPr>
          <a:xfrm>
            <a:off x="1665360" y="1434960"/>
            <a:ext cx="3527280" cy="417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ゴシック"/>
              </a:rPr>
              <a:t>RT-PCR primers: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ゴシック"/>
              </a:rPr>
              <a:t>STIM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Forward 5'‑CCAGGATCTCTGGTGGAGAA‑3'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Reverse 5'‑ATTCGTGTGTTTCGGCTACC‑3'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ゴシック"/>
              </a:rPr>
              <a:t>STIM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Forward 5'‑TCCACCCTACCCTATTGCTG‑3'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Reverse 5'‑CAGGGAAAGCTCGTCTCTTG‑3'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ANF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Forward 5'‑TGCCGGTAGAAGATGAGGTC‑3'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Reverse 5'‑AGCCCTCAGTTTGCTTTTCA‑3'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BNP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Forward 5’-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TGAAGGTGCTGTCCCAG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‑3'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Reverse 5’-CCGATCCGGTCTATCTTGTG‑3'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Forward 5’‑GCTACAGCTTCACCACCACA‑3'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Reverse 5'‑ACATCTGCTGGAAGGTGGAC‑3‘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15T04:04:16Z</dcterms:created>
  <dc:creator>yakuri</dc:creator>
  <dc:description/>
  <dc:language>en-US</dc:language>
  <cp:lastModifiedBy>大場</cp:lastModifiedBy>
  <cp:lastPrinted>2015-12-24T02:42:41Z</cp:lastPrinted>
  <dcterms:modified xsi:type="dcterms:W3CDTF">2016-11-02T01:44:48Z</dcterms:modified>
  <cp:revision>481</cp:revision>
  <dc:subject/>
  <dc:title>PowerPoint プレゼンテーション</dc:title>
</cp:coreProperties>
</file>